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2"/>
  </p:normalViewPr>
  <p:slideViewPr>
    <p:cSldViewPr snapToGrid="0" showGuides="1">
      <p:cViewPr>
        <p:scale>
          <a:sx n="100" d="100"/>
          <a:sy n="100" d="100"/>
        </p:scale>
        <p:origin x="904" y="20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0C71F5-A3D5-FE4E-BA63-95B45BF4EDDC}" type="datetimeFigureOut">
              <a:rPr lang="en-US" smtClean="0"/>
              <a:t>11/29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AC2167-25D1-5D42-A7DD-4EA8571F32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8430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6AC2167-25D1-5D42-A7DD-4EA8571F32B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6094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186097-9D8E-1F21-04BF-6BEC03144F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136DD0-1E9A-1696-0B55-5D91C7BD62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2177B0-F626-4B33-E651-77D6F41EF6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C54AC-D2CF-4547-965C-54D5D8717954}" type="datetimeFigureOut">
              <a:rPr lang="en-US" smtClean="0"/>
              <a:t>11/2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35FD71-A7ED-3888-E9FC-AA52A02EF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61D598-5BA6-62BB-496D-84A640880A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6C0DF-8191-EA4F-8465-F6D7049760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7279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5D2265-9FB6-BC22-68DE-2C7AB91111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2A3B40-98E9-C675-C28B-3D4ECC0F77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39E5E3-26D7-7055-2E28-D44C1247F0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C54AC-D2CF-4547-965C-54D5D8717954}" type="datetimeFigureOut">
              <a:rPr lang="en-US" smtClean="0"/>
              <a:t>11/2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AAF4EE-B48F-9D8F-16E2-312237F8C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CE049F-55C4-AC7D-77C9-E18002A8C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6C0DF-8191-EA4F-8465-F6D7049760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039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8780FE8-55B6-1916-BD56-95FB6EE8C7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5D5BF9-B049-8CBF-EEFB-2873575F4E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741C75-2BE8-FF60-46C0-8BD2382A2C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C54AC-D2CF-4547-965C-54D5D8717954}" type="datetimeFigureOut">
              <a:rPr lang="en-US" smtClean="0"/>
              <a:t>11/2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5168CF-7407-E318-247E-750F870002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B57FEB-8061-8AD9-DD85-C9649F4F3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6C0DF-8191-EA4F-8465-F6D7049760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4746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F821B7-730D-FCBD-A4C3-01BC812104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97AB80-75CE-DC24-829A-D8F1B76184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5A9C19-8B94-0A35-5AB1-F562CF463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C54AC-D2CF-4547-965C-54D5D8717954}" type="datetimeFigureOut">
              <a:rPr lang="en-US" smtClean="0"/>
              <a:t>11/2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AF35BC-374D-F040-4CB3-0B5AF445E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D85F46-E30D-895F-8DE8-8C03FDA291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6C0DF-8191-EA4F-8465-F6D7049760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8857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B5364B-B77C-E1AB-4880-B94B9D678E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54B969-511E-DF5C-9F63-E2CF96B180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4502D9-29C3-F8FD-BD9E-6008992089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C54AC-D2CF-4547-965C-54D5D8717954}" type="datetimeFigureOut">
              <a:rPr lang="en-US" smtClean="0"/>
              <a:t>11/2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DC8017-353B-3EEB-8D00-8A57C79A7F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89B0A3-8322-7A3E-92D4-D3F674BC2C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6C0DF-8191-EA4F-8465-F6D7049760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563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BCC31C-FA9F-CB43-A42E-9CEE11415A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31EE64-C7E3-1AED-1383-BE37143432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06108D-DCF9-40A9-8528-BC43011F52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4D04B8-8E59-EF4E-9AD4-D1398680E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C54AC-D2CF-4547-965C-54D5D8717954}" type="datetimeFigureOut">
              <a:rPr lang="en-US" smtClean="0"/>
              <a:t>11/2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508D44-E671-62CA-D5D4-E6DE3F691A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FC5ECB-19AB-2E37-BB7C-E9355ADA27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6C0DF-8191-EA4F-8465-F6D7049760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755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706929-BAA8-7442-E55E-99407CEEAC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A0EB14-903D-0955-1A54-333CDB805B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BD15F1-3924-D619-6104-F68BFDDB4C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A964E6F-9FAA-C3C7-01F0-3E1670E88D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42F6C4-7D08-E180-C46B-781A21DF43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51175A3-A519-0A84-B372-BD76423EC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C54AC-D2CF-4547-965C-54D5D8717954}" type="datetimeFigureOut">
              <a:rPr lang="en-US" smtClean="0"/>
              <a:t>11/29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F53B212-0D80-E6C7-1639-0B8FA031B8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9F87354-F34F-B5CC-02A2-16CAD06E27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6C0DF-8191-EA4F-8465-F6D7049760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182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FEE354-D059-F4CD-D702-E705806B3E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6A7EF31-7D0F-830F-BE6D-06576D2AA3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C54AC-D2CF-4547-965C-54D5D8717954}" type="datetimeFigureOut">
              <a:rPr lang="en-US" smtClean="0"/>
              <a:t>11/29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70D9742-AC79-A199-6763-32F15226F8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C0A6FDE-BD29-7497-5DEA-8B7187F5B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6C0DF-8191-EA4F-8465-F6D7049760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69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80BB735-B126-51DD-0C5B-3D9BD0C0C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C54AC-D2CF-4547-965C-54D5D8717954}" type="datetimeFigureOut">
              <a:rPr lang="en-US" smtClean="0"/>
              <a:t>11/29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E43B34-2461-CD07-C38C-36BB06E486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89F4A12-C9C1-C2F5-58A8-0A60BF066D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6C0DF-8191-EA4F-8465-F6D7049760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2208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3AAD66-CD09-D07A-8DF2-E87769305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838B8C-D5AF-F3E3-362A-2D44C02C68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08C7EE-8071-9D10-8002-21956433A2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10EC45-485D-C620-7548-EDBA036754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C54AC-D2CF-4547-965C-54D5D8717954}" type="datetimeFigureOut">
              <a:rPr lang="en-US" smtClean="0"/>
              <a:t>11/2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42207B-A679-70D6-FEB4-C139A474C9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643AB1-6D37-3092-3AE4-6E806BA077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6C0DF-8191-EA4F-8465-F6D7049760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036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48971C-9C4B-5A9C-FF32-A00E64B180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91CF108-C824-9BD8-4115-4312BD9779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183D2E-3034-6E0B-B954-7083357325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F258BA-7B04-D7E0-6D6F-D5CB2DF70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0C54AC-D2CF-4547-965C-54D5D8717954}" type="datetimeFigureOut">
              <a:rPr lang="en-US" smtClean="0"/>
              <a:t>11/2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928ADF-953A-B1F4-7B05-B06513FAB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DBB534-B0A1-0FDD-56F8-6EA57DB03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6C0DF-8191-EA4F-8465-F6D7049760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855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21D58BF-BC78-EF88-E938-BEF4A5C18E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764F71-2A3E-819A-BE1D-6D54B3543F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A17258-4355-70B4-1D0F-8A036C4541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C0C54AC-D2CF-4547-965C-54D5D8717954}" type="datetimeFigureOut">
              <a:rPr lang="en-US" smtClean="0"/>
              <a:t>11/2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5F7894-B40B-2095-68AF-70019A9DC1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92A46A-A950-3C81-C167-8DE2B499F3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DD6C0DF-8191-EA4F-8465-F6D7049760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650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8DB31504-123F-BCA5-950E-DF07B37A1CA5}"/>
              </a:ext>
            </a:extLst>
          </p:cNvPr>
          <p:cNvGrpSpPr/>
          <p:nvPr/>
        </p:nvGrpSpPr>
        <p:grpSpPr>
          <a:xfrm>
            <a:off x="63941" y="-62482"/>
            <a:ext cx="9865291" cy="7015206"/>
            <a:chOff x="1798886" y="4424"/>
            <a:chExt cx="9865291" cy="7015206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CFFE2F72-FA1A-DBB5-2D83-E9CDC8CE1616}"/>
                </a:ext>
              </a:extLst>
            </p:cNvPr>
            <p:cNvGrpSpPr/>
            <p:nvPr/>
          </p:nvGrpSpPr>
          <p:grpSpPr>
            <a:xfrm>
              <a:off x="1798886" y="4424"/>
              <a:ext cx="9865291" cy="6082640"/>
              <a:chOff x="1798886" y="1264513"/>
              <a:chExt cx="9865291" cy="6082640"/>
            </a:xfrm>
          </p:grpSpPr>
          <p:pic>
            <p:nvPicPr>
              <p:cNvPr id="4" name="Content Placeholder 4" descr="A screenshot of a computer screen&#10;&#10;Description automatically generated">
                <a:extLst>
                  <a:ext uri="{FF2B5EF4-FFF2-40B4-BE49-F238E27FC236}">
                    <a16:creationId xmlns:a16="http://schemas.microsoft.com/office/drawing/2014/main" id="{A5B67405-1615-B534-87DB-404922C4922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55" b="90988"/>
              <a:stretch/>
            </p:blipFill>
            <p:spPr>
              <a:xfrm>
                <a:off x="1798886" y="1264513"/>
                <a:ext cx="9865291" cy="2328628"/>
              </a:xfrm>
              <a:prstGeom prst="rect">
                <a:avLst/>
              </a:prstGeom>
            </p:spPr>
          </p:pic>
          <p:pic>
            <p:nvPicPr>
              <p:cNvPr id="5" name="Content Placeholder 4" descr="A screenshot of a computer screen&#10;&#10;Description automatically generated">
                <a:extLst>
                  <a:ext uri="{FF2B5EF4-FFF2-40B4-BE49-F238E27FC236}">
                    <a16:creationId xmlns:a16="http://schemas.microsoft.com/office/drawing/2014/main" id="{12237D3C-A603-0ECF-A4BF-BD7E3399809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66267" b="20414"/>
              <a:stretch/>
            </p:blipFill>
            <p:spPr>
              <a:xfrm>
                <a:off x="1798887" y="3568391"/>
                <a:ext cx="9865290" cy="3778762"/>
              </a:xfrm>
              <a:prstGeom prst="rect">
                <a:avLst/>
              </a:prstGeom>
            </p:spPr>
          </p:pic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5631EE0-D6E0-5265-E09F-9307387CB264}"/>
                </a:ext>
              </a:extLst>
            </p:cNvPr>
            <p:cNvSpPr txBox="1"/>
            <p:nvPr/>
          </p:nvSpPr>
          <p:spPr>
            <a:xfrm rot="16200000">
              <a:off x="2159732" y="6004261"/>
              <a:ext cx="8306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ltai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3FEDD3B-BBC6-052A-E3B8-5716AC7CA54B}"/>
                </a:ext>
              </a:extLst>
            </p:cNvPr>
            <p:cNvSpPr txBox="1"/>
            <p:nvPr/>
          </p:nvSpPr>
          <p:spPr>
            <a:xfrm rot="16200000">
              <a:off x="2720492" y="6304017"/>
              <a:ext cx="10618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Hereford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6CFCD25-6CFE-76DC-C010-EBC035303FD7}"/>
                </a:ext>
              </a:extLst>
            </p:cNvPr>
            <p:cNvSpPr txBox="1"/>
            <p:nvPr/>
          </p:nvSpPr>
          <p:spPr>
            <a:xfrm rot="16200000">
              <a:off x="6597208" y="6122614"/>
              <a:ext cx="6827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KWH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0E7C300-0027-79D6-8A49-46F161A4BFB4}"/>
                </a:ext>
              </a:extLst>
            </p:cNvPr>
            <p:cNvSpPr txBox="1"/>
            <p:nvPr/>
          </p:nvSpPr>
          <p:spPr>
            <a:xfrm rot="16200000">
              <a:off x="7064263" y="6239184"/>
              <a:ext cx="9099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Kalmyk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F68777F-931C-65BA-76BC-B6FC56C3EE4A}"/>
                </a:ext>
              </a:extLst>
            </p:cNvPr>
            <p:cNvSpPr txBox="1"/>
            <p:nvPr/>
          </p:nvSpPr>
          <p:spPr>
            <a:xfrm rot="16200000">
              <a:off x="7305339" y="6240967"/>
              <a:ext cx="9003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Kazakh</a:t>
              </a:r>
            </a:p>
          </p:txBody>
        </p:sp>
      </p:grp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099012EB-BDC3-B164-73A7-45B40D5C1FF2}"/>
              </a:ext>
            </a:extLst>
          </p:cNvPr>
          <p:cNvCxnSpPr>
            <a:cxnSpLocks/>
          </p:cNvCxnSpPr>
          <p:nvPr/>
        </p:nvCxnSpPr>
        <p:spPr>
          <a:xfrm>
            <a:off x="5835883" y="5932539"/>
            <a:ext cx="171627" cy="7287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F5467CC2-96BF-02D2-4EC0-17649F666DAB}"/>
              </a:ext>
            </a:extLst>
          </p:cNvPr>
          <p:cNvSpPr txBox="1"/>
          <p:nvPr/>
        </p:nvSpPr>
        <p:spPr>
          <a:xfrm>
            <a:off x="8647446" y="0"/>
            <a:ext cx="3631956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. </a:t>
            </a:r>
            <a:r>
              <a:rPr lang="en-US" b="1" dirty="0"/>
              <a:t>Admixture analysis of </a:t>
            </a:r>
          </a:p>
          <a:p>
            <a:r>
              <a:rPr lang="en-US" b="1" dirty="0"/>
              <a:t>26 cattle breeds selected based </a:t>
            </a:r>
          </a:p>
          <a:p>
            <a:r>
              <a:rPr lang="en-US" b="1" dirty="0"/>
              <a:t>on Hudson F</a:t>
            </a:r>
            <a:r>
              <a:rPr lang="en-US" b="1" i="1" baseline="-25000" dirty="0"/>
              <a:t>ST</a:t>
            </a:r>
            <a:r>
              <a:rPr lang="en-US" b="1" i="1" dirty="0"/>
              <a:t>.</a:t>
            </a:r>
            <a:r>
              <a:rPr lang="en-US" i="1" dirty="0"/>
              <a:t> </a:t>
            </a:r>
            <a:r>
              <a:rPr lang="en-US" dirty="0"/>
              <a:t>Breeds with </a:t>
            </a:r>
          </a:p>
          <a:p>
            <a:r>
              <a:rPr lang="en-US" dirty="0"/>
              <a:t>putative contribution to Kazakh </a:t>
            </a:r>
          </a:p>
          <a:p>
            <a:r>
              <a:rPr lang="en-US" dirty="0" err="1"/>
              <a:t>Whiteheaded</a:t>
            </a:r>
            <a:r>
              <a:rPr lang="en-US" dirty="0"/>
              <a:t> (KWH) genetics are </a:t>
            </a:r>
          </a:p>
          <a:p>
            <a:r>
              <a:rPr lang="en-US" dirty="0"/>
              <a:t>shown. </a:t>
            </a:r>
            <a:r>
              <a:rPr lang="en-GB" dirty="0"/>
              <a:t>K2, K2 indicate relations of </a:t>
            </a:r>
          </a:p>
          <a:p>
            <a:r>
              <a:rPr lang="en-GB" dirty="0"/>
              <a:t>KWH and Hereford, while K19 </a:t>
            </a:r>
          </a:p>
          <a:p>
            <a:r>
              <a:rPr lang="en-GB" dirty="0"/>
              <a:t>show contributions of Altai and </a:t>
            </a:r>
          </a:p>
          <a:p>
            <a:r>
              <a:rPr lang="en-GB" dirty="0"/>
              <a:t>Kalmyk populations. </a:t>
            </a:r>
            <a:r>
              <a:rPr lang="en-US" dirty="0"/>
              <a:t> </a:t>
            </a:r>
          </a:p>
          <a:p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2936853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56</Words>
  <Application>Microsoft Macintosh PowerPoint</Application>
  <PresentationFormat>Widescreen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rosoft Office User</dc:creator>
  <cp:lastModifiedBy>Microsoft Office User</cp:lastModifiedBy>
  <cp:revision>3</cp:revision>
  <dcterms:created xsi:type="dcterms:W3CDTF">2024-11-29T13:48:06Z</dcterms:created>
  <dcterms:modified xsi:type="dcterms:W3CDTF">2024-11-29T14:23:42Z</dcterms:modified>
</cp:coreProperties>
</file>